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516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1D83F"/>
    <a:srgbClr val="9CEA45"/>
    <a:srgbClr val="5B994B"/>
    <a:srgbClr val="A2CE37"/>
    <a:srgbClr val="7CB84B"/>
    <a:srgbClr val="A455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25" autoAdjust="0"/>
    <p:restoredTop sz="50000" autoAdjust="0"/>
  </p:normalViewPr>
  <p:slideViewPr>
    <p:cSldViewPr snapToGrid="0" snapToObjects="1" showGuides="1">
      <p:cViewPr>
        <p:scale>
          <a:sx n="130" d="100"/>
          <a:sy n="130" d="100"/>
        </p:scale>
        <p:origin x="1048" y="-216"/>
      </p:cViewPr>
      <p:guideLst>
        <p:guide orient="horz" pos="3657"/>
        <p:guide pos="51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426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43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59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53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830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09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68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0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988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674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1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922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48660" y="3568466"/>
            <a:ext cx="6968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1. </a:t>
            </a:r>
            <a:endParaRPr lang="en-US" sz="12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7506827"/>
              </p:ext>
            </p:extLst>
          </p:nvPr>
        </p:nvGraphicFramePr>
        <p:xfrm>
          <a:off x="511001" y="426173"/>
          <a:ext cx="8029493" cy="4862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59261"/>
                <a:gridCol w="341738"/>
                <a:gridCol w="385550"/>
                <a:gridCol w="295258"/>
                <a:gridCol w="530352"/>
                <a:gridCol w="512064"/>
                <a:gridCol w="310896"/>
                <a:gridCol w="260946"/>
                <a:gridCol w="411257"/>
                <a:gridCol w="452509"/>
                <a:gridCol w="262721"/>
                <a:gridCol w="384436"/>
                <a:gridCol w="295032"/>
                <a:gridCol w="429138"/>
                <a:gridCol w="321853"/>
                <a:gridCol w="357615"/>
                <a:gridCol w="357615"/>
                <a:gridCol w="339734"/>
                <a:gridCol w="488832"/>
                <a:gridCol w="374904"/>
                <a:gridCol w="557782"/>
              </a:tblGrid>
              <a:tr h="285392"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aCGH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u="none" strike="noStrike" smtClean="0">
                          <a:effectLst/>
                        </a:rPr>
                        <a:t>SNP array</a:t>
                      </a:r>
                      <a:endParaRPr lang="en-US" sz="1000" b="1" i="0" u="none" strike="noStrike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SNCA ddPC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EIF2C1 ddPC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TSC2 ddPC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WG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</a:tr>
              <a:tr h="25250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od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regio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CER v </a:t>
                      </a:r>
                      <a:r>
                        <a:rPr lang="en-US" sz="800" b="1" u="none" strike="noStrike" dirty="0">
                          <a:effectLst/>
                        </a:rPr>
                        <a:t>PBL D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 smtClean="0">
                          <a:effectLst/>
                        </a:rPr>
                        <a:t>Cer</a:t>
                      </a:r>
                      <a:r>
                        <a:rPr lang="en-US" sz="800" b="1" u="none" strike="noStrike" dirty="0" smtClean="0">
                          <a:effectLst/>
                        </a:rPr>
                        <a:t> v FC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 smtClean="0">
                          <a:effectLst/>
                        </a:rPr>
                        <a:t>Repeat 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 smtClean="0">
                          <a:effectLst/>
                        </a:rPr>
                        <a:t>Repeat 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S/C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ON S/C 25m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P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S/C</a:t>
                      </a:r>
                    </a:p>
                    <a:p>
                      <a:pPr algn="ctr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S/C ON 25mg</a:t>
                      </a:r>
                      <a:r>
                        <a:rPr lang="en-US" sz="800" b="1" u="none" strike="noStrike" baseline="0" dirty="0" smtClean="0">
                          <a:effectLst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P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S/C ON 5m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S/C</a:t>
                      </a:r>
                    </a:p>
                    <a:p>
                      <a:pPr algn="ctr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S/C ON 25m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u="none" strike="noStrike" dirty="0" smtClean="0">
                          <a:effectLst/>
                        </a:rPr>
                        <a:t>PG</a:t>
                      </a:r>
                      <a:endParaRPr lang="en-US" sz="800" b="1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S/C ON 5m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u="none" strike="noStrike" dirty="0" smtClean="0">
                          <a:effectLst/>
                        </a:rPr>
                        <a:t>digest S/C</a:t>
                      </a:r>
                      <a:endParaRPr lang="en-US" sz="800" b="1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 25mg 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smtClean="0">
                          <a:effectLst/>
                        </a:rPr>
                        <a:t>digest P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</a:tr>
              <a:tr h="283801">
                <a:tc rowSpan="2"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>
                          <a:effectLst/>
                        </a:rPr>
                        <a:t>PD1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l" fontAlgn="b"/>
                      <a:r>
                        <a:rPr lang="sk-SK" sz="1000" b="1" u="none" strike="noStrike" dirty="0">
                          <a:effectLst/>
                        </a:rPr>
                        <a:t> 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x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PG (test</a:t>
                      </a:r>
                      <a:r>
                        <a:rPr lang="en-US" sz="900" u="none" strike="noStrike" dirty="0">
                          <a:effectLst/>
                        </a:rPr>
                        <a:t>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900"/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</a:tr>
              <a:tr h="283801">
                <a:tc vMerge="1">
                  <a:txBody>
                    <a:bodyPr/>
                    <a:lstStyle/>
                    <a:p>
                      <a:pPr algn="l" fontAlgn="b"/>
                      <a:endParaRPr lang="sk-SK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F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PG</a:t>
                      </a:r>
                      <a:r>
                        <a:rPr lang="en-US" sz="900" u="none" strike="noStrike" baseline="0" dirty="0" smtClean="0">
                          <a:effectLst/>
                        </a:rPr>
                        <a:t> </a:t>
                      </a:r>
                      <a:r>
                        <a:rPr lang="en-US" sz="900" u="none" strike="noStrike" dirty="0" smtClean="0">
                          <a:effectLst/>
                        </a:rPr>
                        <a:t>(ref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900"/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</a:tr>
              <a:tr h="158601">
                <a:tc rowSpan="2"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>
                          <a:effectLst/>
                        </a:rPr>
                        <a:t>PD2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l" fontAlgn="b"/>
                      <a:r>
                        <a:rPr lang="sk-SK" sz="1000" b="1" u="none" strike="noStrike" dirty="0">
                          <a:effectLst/>
                        </a:rPr>
                        <a:t> 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>
                          <a:effectLst/>
                        </a:rPr>
                        <a:t>x 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</a:tr>
              <a:tr h="252501">
                <a:tc vMerge="1">
                  <a:txBody>
                    <a:bodyPr/>
                    <a:lstStyle/>
                    <a:p>
                      <a:pPr algn="l" fontAlgn="b"/>
                      <a:endParaRPr lang="sk-SK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F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(+dye flip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</a:tr>
              <a:tr h="472447">
                <a:tc rowSpan="2"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>
                          <a:effectLst/>
                        </a:rPr>
                        <a:t>PD3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l" fontAlgn="b"/>
                      <a:r>
                        <a:rPr lang="sk-SK" sz="1000" b="1" u="none" strike="noStrike" dirty="0">
                          <a:effectLst/>
                        </a:rPr>
                        <a:t> 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25mg SC ON (test</a:t>
                      </a:r>
                      <a:r>
                        <a:rPr lang="en-US" sz="900" u="none" strike="noStrike" dirty="0">
                          <a:effectLst/>
                        </a:rPr>
                        <a:t>), </a:t>
                      </a:r>
                      <a:endParaRPr lang="en-US" sz="900" u="none" strike="noStrike" dirty="0" smtClean="0">
                        <a:effectLst/>
                      </a:endParaRP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PG</a:t>
                      </a:r>
                      <a:r>
                        <a:rPr lang="en-US" sz="900" u="none" strike="noStrike" baseline="0" dirty="0" smtClean="0">
                          <a:effectLst/>
                        </a:rPr>
                        <a:t> </a:t>
                      </a:r>
                      <a:r>
                        <a:rPr lang="en-US" sz="900" u="none" strike="noStrike" dirty="0" smtClean="0">
                          <a:effectLst/>
                        </a:rPr>
                        <a:t>(ref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5mg </a:t>
                      </a:r>
                      <a:r>
                        <a:rPr lang="en-US" sz="900" u="none" strike="noStrike" dirty="0" smtClean="0">
                          <a:effectLst/>
                        </a:rPr>
                        <a:t>SC ON </a:t>
                      </a:r>
                      <a:r>
                        <a:rPr lang="en-US" sz="900" u="none" strike="noStrike" dirty="0">
                          <a:effectLst/>
                        </a:rPr>
                        <a:t>(test</a:t>
                      </a:r>
                      <a:r>
                        <a:rPr lang="en-US" sz="900" u="none" strike="noStrike" dirty="0" smtClean="0">
                          <a:effectLst/>
                        </a:rPr>
                        <a:t>), PG (ref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25mg </a:t>
                      </a:r>
                      <a:r>
                        <a:rPr lang="en-US" sz="900" u="none" strike="noStrike" dirty="0" smtClean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SC ON</a:t>
                      </a:r>
                      <a:r>
                        <a:rPr lang="en-US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, </a:t>
                      </a:r>
                      <a:r>
                        <a:rPr lang="en-US" sz="900" u="none" strike="noStrike" dirty="0" smtClean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P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</a:tr>
              <a:tr h="158601">
                <a:tc vMerge="1">
                  <a:txBody>
                    <a:bodyPr/>
                    <a:lstStyle/>
                    <a:p>
                      <a:pPr algn="l" fontAlgn="b"/>
                      <a:endParaRPr lang="sk-SK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F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</a:tr>
              <a:tr h="377701">
                <a:tc rowSpan="2"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>
                          <a:effectLst/>
                        </a:rPr>
                        <a:t>PD4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l" fontAlgn="b"/>
                      <a:r>
                        <a:rPr lang="sk-SK" sz="1000" b="1" u="none" strike="noStrike" dirty="0">
                          <a:effectLst/>
                        </a:rPr>
                        <a:t> 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5mg </a:t>
                      </a:r>
                      <a:r>
                        <a:rPr lang="en-US" sz="900" u="none" strike="noStrike" dirty="0" smtClean="0">
                          <a:effectLst/>
                        </a:rPr>
                        <a:t>SC ON </a:t>
                      </a:r>
                      <a:r>
                        <a:rPr lang="en-US" sz="900" u="none" strike="noStrike" dirty="0">
                          <a:effectLst/>
                        </a:rPr>
                        <a:t>(test), </a:t>
                      </a:r>
                      <a:endParaRPr lang="en-US" sz="900" u="none" strike="noStrike" dirty="0" smtClean="0">
                        <a:effectLst/>
                      </a:endParaRP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PG </a:t>
                      </a:r>
                      <a:r>
                        <a:rPr lang="en-US" sz="900" u="none" strike="noStrike" dirty="0">
                          <a:effectLst/>
                        </a:rPr>
                        <a:t>(</a:t>
                      </a:r>
                      <a:r>
                        <a:rPr lang="en-US" sz="900" u="none" strike="noStrike" dirty="0" smtClean="0">
                          <a:effectLst/>
                        </a:rPr>
                        <a:t>ref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</a:tr>
              <a:tr h="158601">
                <a:tc vMerge="1">
                  <a:txBody>
                    <a:bodyPr/>
                    <a:lstStyle/>
                    <a:p>
                      <a:pPr algn="l" fontAlgn="b"/>
                      <a:endParaRPr lang="sk-SK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F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</a:tr>
              <a:tr h="158601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l" fontAlgn="b"/>
                      <a:r>
                        <a:rPr lang="sk-SK" sz="1000" b="1" u="none" strike="noStrike" dirty="0">
                          <a:effectLst/>
                        </a:rPr>
                        <a:t> 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</a:tr>
              <a:tr h="158601">
                <a:tc vMerge="1">
                  <a:txBody>
                    <a:bodyPr/>
                    <a:lstStyle/>
                    <a:p>
                      <a:pPr algn="l" fontAlgn="b"/>
                      <a:endParaRPr lang="sk-SK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F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</a:tr>
              <a:tr h="158601">
                <a:tc rowSpan="2">
                  <a:txBody>
                    <a:bodyPr/>
                    <a:lstStyle/>
                    <a:p>
                      <a:pPr algn="l" fontAlgn="b"/>
                      <a:r>
                        <a:rPr lang="is-IS" sz="1000" b="1" u="none" strike="noStrike" dirty="0">
                          <a:effectLst/>
                        </a:rPr>
                        <a:t>c2</a:t>
                      </a:r>
                      <a:endParaRPr lang="is-I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l" fontAlgn="b"/>
                      <a:r>
                        <a:rPr lang="sk-SK" sz="1000" b="1" u="none" strike="noStrike" dirty="0">
                          <a:effectLst/>
                        </a:rPr>
                        <a:t> 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 smtClean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</a:tr>
              <a:tr h="158601">
                <a:tc vMerge="1">
                  <a:txBody>
                    <a:bodyPr/>
                    <a:lstStyle/>
                    <a:p>
                      <a:pPr algn="l" fontAlgn="b"/>
                      <a:endParaRPr lang="sk-SK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F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</a:tr>
              <a:tr h="158601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l" fontAlgn="b"/>
                      <a:r>
                        <a:rPr lang="sk-SK" sz="1000" b="1" u="none" strike="noStrike" dirty="0">
                          <a:effectLst/>
                        </a:rPr>
                        <a:t> 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</a:tr>
              <a:tr h="158601">
                <a:tc vMerge="1">
                  <a:txBody>
                    <a:bodyPr/>
                    <a:lstStyle/>
                    <a:p>
                      <a:pPr algn="l" fontAlgn="b"/>
                      <a:endParaRPr lang="sk-SK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F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</a:tr>
              <a:tr h="158601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l" fontAlgn="b"/>
                      <a:r>
                        <a:rPr lang="sk-SK" sz="1000" b="1" u="none" strike="noStrike" dirty="0">
                          <a:effectLst/>
                        </a:rPr>
                        <a:t> 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C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91D83F"/>
                    </a:solidFill>
                  </a:tcPr>
                </a:tc>
              </a:tr>
              <a:tr h="158601">
                <a:tc vMerge="1">
                  <a:txBody>
                    <a:bodyPr/>
                    <a:lstStyle/>
                    <a:p>
                      <a:pPr algn="l" fontAlgn="b"/>
                      <a:endParaRPr lang="sk-SK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F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>
                          <a:effectLst/>
                        </a:rPr>
                        <a:t> </a:t>
                      </a:r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u="none" strike="noStrike" dirty="0"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 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rgbClr val="FFC000"/>
                    </a:solidFill>
                  </a:tcPr>
                </a:tc>
              </a:tr>
              <a:tr h="32108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PD5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S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Ph:Chl</a:t>
                      </a:r>
                      <a:r>
                        <a:rPr lang="sk-SK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,</a:t>
                      </a:r>
                      <a:r>
                        <a:rPr lang="sk-SK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 PG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210966">
                <a:tc>
                  <a:txBody>
                    <a:bodyPr/>
                    <a:lstStyle/>
                    <a:p>
                      <a:pPr algn="l" fontAlgn="b"/>
                      <a:r>
                        <a:rPr lang="sk-SK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PD6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S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Ph:Chl</a:t>
                      </a:r>
                      <a:r>
                        <a:rPr lang="sk-SK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,</a:t>
                      </a:r>
                      <a:r>
                        <a:rPr lang="sk-SK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 PG</a:t>
                      </a:r>
                      <a:endParaRPr lang="sk-SK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  <a:p>
                      <a:pPr algn="l" fontAlgn="b"/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25004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ILBD</a:t>
                      </a:r>
                      <a:endParaRPr lang="sk-SK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S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Ph:Chl</a:t>
                      </a:r>
                      <a:r>
                        <a:rPr lang="sk-SK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,</a:t>
                      </a:r>
                      <a:r>
                        <a:rPr lang="sk-SK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Calibri" charset="0"/>
                        </a:rPr>
                        <a:t> PG</a:t>
                      </a:r>
                      <a:endParaRPr lang="sk-SK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  <a:p>
                      <a:pPr algn="l" fontAlgn="b"/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2046" marR="2046" marT="2046" marB="0" anchor="b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870626" y="5645290"/>
            <a:ext cx="72694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1. Summary of all samples and experiments. CER</a:t>
            </a:r>
            <a:r>
              <a:rPr lang="en-US" sz="1200" b="1" smtClean="0"/>
              <a:t>= cerebellum. ON</a:t>
            </a:r>
            <a:r>
              <a:rPr lang="en-US" sz="1200" b="1" dirty="0" smtClean="0"/>
              <a:t>= overnight. S/C= spin column. PG= </a:t>
            </a:r>
            <a:r>
              <a:rPr lang="en-US" sz="1200" b="1" dirty="0" err="1" smtClean="0"/>
              <a:t>puregene</a:t>
            </a:r>
            <a:r>
              <a:rPr lang="en-US" sz="1200" b="1" dirty="0" smtClean="0"/>
              <a:t>. Ref= used as reference DNA in aCGH. Individual experiments explained in text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74502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66</TotalTime>
  <Words>268</Words>
  <Application>Microsoft Macintosh PowerPoint</Application>
  <PresentationFormat>On-screen Show (4:3)</PresentationFormat>
  <Paragraphs>3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Company>UCLMS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Proukakis</dc:creator>
  <cp:lastModifiedBy>Christos Proukakis</cp:lastModifiedBy>
  <cp:revision>566</cp:revision>
  <dcterms:created xsi:type="dcterms:W3CDTF">2015-06-01T09:06:36Z</dcterms:created>
  <dcterms:modified xsi:type="dcterms:W3CDTF">2017-06-21T19:48:45Z</dcterms:modified>
</cp:coreProperties>
</file>